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675325" y="188833"/>
            <a:ext cx="2296475" cy="5696029"/>
            <a:chOff x="304321" y="188833"/>
            <a:chExt cx="2296475" cy="5696029"/>
          </a:xfrm>
        </p:grpSpPr>
        <p:pic>
          <p:nvPicPr>
            <p:cNvPr id="2062" name="Picture 14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923" y="188833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4598" y="1600200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5" name="Picture 17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321" y="4419600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6" name="Picture 18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582" y="3047881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4" name="Rectangle 77"/>
            <p:cNvSpPr>
              <a:spLocks noChangeArrowheads="1"/>
            </p:cNvSpPr>
            <p:nvPr/>
          </p:nvSpPr>
          <p:spPr bwMode="auto">
            <a:xfrm>
              <a:off x="1219200" y="5715000"/>
              <a:ext cx="280988" cy="169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Int2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78"/>
            <p:cNvSpPr>
              <a:spLocks noChangeArrowheads="1"/>
            </p:cNvSpPr>
            <p:nvPr/>
          </p:nvSpPr>
          <p:spPr bwMode="auto">
            <a:xfrm>
              <a:off x="1701800" y="5715000"/>
              <a:ext cx="279400" cy="169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Int3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79"/>
            <p:cNvSpPr>
              <a:spLocks noChangeArrowheads="1"/>
            </p:cNvSpPr>
            <p:nvPr/>
          </p:nvSpPr>
          <p:spPr bwMode="auto">
            <a:xfrm>
              <a:off x="2209800" y="5715000"/>
              <a:ext cx="279400" cy="169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Int4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79"/>
            <p:cNvSpPr>
              <a:spLocks noChangeArrowheads="1"/>
            </p:cNvSpPr>
            <p:nvPr/>
          </p:nvSpPr>
          <p:spPr bwMode="auto">
            <a:xfrm>
              <a:off x="685800" y="5713512"/>
              <a:ext cx="22762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Int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3352800" y="188832"/>
            <a:ext cx="2306913" cy="4324430"/>
            <a:chOff x="3352800" y="188832"/>
            <a:chExt cx="2306913" cy="4324430"/>
          </a:xfrm>
        </p:grpSpPr>
        <p:pic>
          <p:nvPicPr>
            <p:cNvPr id="2069" name="Picture 21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52800" y="188832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70" name="Picture 22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52800" y="1600200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71" name="Picture 23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73515" y="3048000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9" name="Rectangle 77"/>
            <p:cNvSpPr>
              <a:spLocks noChangeArrowheads="1"/>
            </p:cNvSpPr>
            <p:nvPr/>
          </p:nvSpPr>
          <p:spPr bwMode="auto">
            <a:xfrm>
              <a:off x="4291012" y="4343400"/>
              <a:ext cx="280988" cy="169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Int2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78"/>
            <p:cNvSpPr>
              <a:spLocks noChangeArrowheads="1"/>
            </p:cNvSpPr>
            <p:nvPr/>
          </p:nvSpPr>
          <p:spPr bwMode="auto">
            <a:xfrm>
              <a:off x="4800600" y="4343400"/>
              <a:ext cx="279400" cy="169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Int3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79"/>
            <p:cNvSpPr>
              <a:spLocks noChangeArrowheads="1"/>
            </p:cNvSpPr>
            <p:nvPr/>
          </p:nvSpPr>
          <p:spPr bwMode="auto">
            <a:xfrm>
              <a:off x="5257800" y="4343400"/>
              <a:ext cx="279400" cy="169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Int4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79"/>
            <p:cNvSpPr>
              <a:spLocks noChangeArrowheads="1"/>
            </p:cNvSpPr>
            <p:nvPr/>
          </p:nvSpPr>
          <p:spPr bwMode="auto">
            <a:xfrm>
              <a:off x="3809521" y="4343400"/>
              <a:ext cx="22762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Int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6172200" y="228481"/>
            <a:ext cx="2286198" cy="4284781"/>
            <a:chOff x="6172200" y="228481"/>
            <a:chExt cx="2286198" cy="4284781"/>
          </a:xfrm>
        </p:grpSpPr>
        <p:pic>
          <p:nvPicPr>
            <p:cNvPr id="2073" name="Picture 25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72200" y="228481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74" name="Picture 26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72200" y="1600200"/>
              <a:ext cx="2286198" cy="137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" name="Group 2"/>
            <p:cNvGrpSpPr/>
            <p:nvPr/>
          </p:nvGrpSpPr>
          <p:grpSpPr>
            <a:xfrm>
              <a:off x="6172200" y="3047880"/>
              <a:ext cx="2286198" cy="1465382"/>
              <a:chOff x="6172200" y="3047880"/>
              <a:chExt cx="2286198" cy="1465382"/>
            </a:xfrm>
          </p:grpSpPr>
          <p:pic>
            <p:nvPicPr>
              <p:cNvPr id="2072" name="Picture 24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72200" y="3047880"/>
                <a:ext cx="2286198" cy="137171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0" name="Rectangle 77"/>
              <p:cNvSpPr>
                <a:spLocks noChangeArrowheads="1"/>
              </p:cNvSpPr>
              <p:nvPr/>
            </p:nvSpPr>
            <p:spPr bwMode="auto">
              <a:xfrm>
                <a:off x="7086600" y="4343400"/>
                <a:ext cx="280988" cy="1698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Int2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Rectangle 78"/>
              <p:cNvSpPr>
                <a:spLocks noChangeArrowheads="1"/>
              </p:cNvSpPr>
              <p:nvPr/>
            </p:nvSpPr>
            <p:spPr bwMode="auto">
              <a:xfrm>
                <a:off x="7569200" y="4343400"/>
                <a:ext cx="279400" cy="1698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Int3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79"/>
              <p:cNvSpPr>
                <a:spLocks noChangeArrowheads="1"/>
              </p:cNvSpPr>
              <p:nvPr/>
            </p:nvSpPr>
            <p:spPr bwMode="auto">
              <a:xfrm>
                <a:off x="8077200" y="4343400"/>
                <a:ext cx="279400" cy="1698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Int4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Rectangle 79"/>
              <p:cNvSpPr>
                <a:spLocks noChangeArrowheads="1"/>
              </p:cNvSpPr>
              <p:nvPr/>
            </p:nvSpPr>
            <p:spPr bwMode="auto">
              <a:xfrm>
                <a:off x="6629400" y="4341912"/>
                <a:ext cx="22762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Int1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8" name="TextBox 27"/>
          <p:cNvSpPr txBox="1"/>
          <p:nvPr/>
        </p:nvSpPr>
        <p:spPr>
          <a:xfrm rot="16200000">
            <a:off x="-1789056" y="2985641"/>
            <a:ext cx="441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 expression level determined by RNA-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qPCR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284430" y="5999202"/>
            <a:ext cx="62506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ea typeface="Times New Roman"/>
              </a:rPr>
              <a:t>Additional file 6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of  RNA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sults by qPCR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PK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termined by RNA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expression fold change determined by qPCR from three biological replicates was normalized. Values are mean of three biological replicates and error bars represent S.E.   </a:t>
            </a:r>
          </a:p>
        </p:txBody>
      </p:sp>
    </p:spTree>
    <p:extLst>
      <p:ext uri="{BB962C8B-B14F-4D97-AF65-F5344CB8AC3E}">
        <p14:creationId xmlns:p14="http://schemas.microsoft.com/office/powerpoint/2010/main" xmlns="" val="30763597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62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5:08Z</dcterms:modified>
</cp:coreProperties>
</file>